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5" r:id="rId2"/>
    <p:sldId id="268" r:id="rId3"/>
    <p:sldId id="269" r:id="rId4"/>
    <p:sldId id="270" r:id="rId5"/>
    <p:sldId id="271" r:id="rId6"/>
    <p:sldId id="260" r:id="rId7"/>
    <p:sldId id="257" r:id="rId8"/>
    <p:sldId id="262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0579"/>
    <p:restoredTop sz="94620"/>
  </p:normalViewPr>
  <p:slideViewPr>
    <p:cSldViewPr snapToGrid="0">
      <p:cViewPr varScale="1">
        <p:scale>
          <a:sx n="79" d="100"/>
          <a:sy n="79" d="100"/>
        </p:scale>
        <p:origin x="1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8CF0F2-5EDD-9F47-B312-EA439A3BF4C9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B80760-9B5A-B643-A753-68A726368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9489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ble S1. Binary logistic regression – factors predicting treatment allocation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8430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recurrence-free survival curves in original unmatched ablation and TACE groups</a:t>
            </a:r>
            <a:endParaRPr lang="en-AU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1424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2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local recurrence-free survival curves in original unmatched ablation and TACE group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4845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3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overall survival curves in PSM cohort – Child-Pugh A subgroup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366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4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overall survival curves in PSM cohort – Child-Pugh B subgrou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3799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5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overall survival curves in original unmatched ablation and TACE group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85177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6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Kaplan-Meier liver-related survival curves in original unmatched ablation and TACE group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0863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S2. Competing risks regression – all-cause mortality with liver transplant as competing ev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08524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ble S3. Competing risks regression – liver-related mortality with liver transplant as competing event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B80760-9B5A-B643-A753-68A72636804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445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81F11-B630-625C-94AB-F446516790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DA669F-7D3A-DD21-DC16-4EA07898EC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51DE88-6AD9-DA05-B4FD-CE913A43D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E740DA-A216-7B06-1D0F-2CDC75052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38588-E777-F7F7-9CCE-519C8A103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24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F3E663-200F-60B1-714A-862F096A05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D00237-BF7F-AC45-E8D5-C7C99C80F3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89FFB0-D573-64C0-9890-ABF65515F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D17F6A-634A-B5A1-8C46-D61711A4C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C6ED9A-364F-711A-6AB2-D1BC32F68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79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D493FE-A7A0-E0F3-751D-0F00AA9702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4E724F-0078-0F4C-3A20-6FB7494929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0D757-EA8F-6D3E-51A9-8158C9507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32640E-2BD9-EBEF-823B-2D051CD6D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04AE9-36A6-3684-CF80-215EB7DFA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970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2366BC-C718-1870-5ACE-13DFA4654F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8F7E8D-0E10-76E0-A98B-0B6D1BBF8F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AE69E-C06B-5021-0F0E-151A65B6A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D0B1A1-C832-EAA4-8219-9930E4E53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83A53-FF04-CF9D-FC60-E7B9FDFA8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880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3391F-B77D-EDA4-15DB-5F19AE676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7E2362-EFFD-F93D-7931-9347DBBC51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BC53F8-E4FB-C382-F54B-50A9A0634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478EC-18FA-C15F-84AB-8A05CB42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0EDB3-80BD-66FC-AEA2-9EDE15F6C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36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74C3B-1B1A-A5C2-366B-071866864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476F9-7029-3AC7-4BB6-525A555F79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28D617-1A41-3AB0-85E0-19201DD5F6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547AF7-E94B-3354-82EE-858B71316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A4F8DA-6D26-3EB6-70DF-8AFFABB63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6A3AF3-4CA8-7142-5A88-96BC7C275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42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136AAE-A47A-7F29-ACCD-DD6016516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75BE50-80D0-A6CB-70BE-9CC80C9EA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7C75ED-619E-9D71-DA3E-D97C91969A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A3E73C-5CB8-1AA7-608F-BA822B03BF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574C93-8B1E-8A17-C033-40F5C1D2C7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F4CD48-EBE3-CE1B-EE03-76E83CCE5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C2E176-94D7-8792-8E81-907F6203F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FF7344-BE61-F32A-1FB5-C88B12A57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08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B8771-FC74-5E72-3421-A266D84B6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DF48A9-EF7D-913A-B376-BD964FF57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EF52ED-8E86-2670-A29F-813238566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3CE872-4356-39E7-5119-93D66C04C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14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3B6A7A-7262-A30B-F9FB-8EA820934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52A34A-6E90-90AF-4949-36E1D05A1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9A0204-B5C0-342E-72C3-2C92AEE25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033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DD331-F39C-8F00-2D31-7D354CFEF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AC0FBB-8491-DCCE-F79B-3B019E3C9F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F55699-F6CD-7AD8-06C9-80AC92C0E5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55162C-6487-B37F-BC2B-7E851718F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13139B-BF83-B72E-0109-3F3CB156F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E27CE7-F632-7A1D-204E-8B48DF887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327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63945-3C48-8E27-3749-124E0110B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876220-E929-A64F-7E61-710EC0556F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A21288-2094-750C-70B2-66B2F62E34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753AE8-7DB9-7F2B-8EED-0B3B83C8E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4CA6EF-7D11-52B3-7F47-09D0DB7D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F6F87B-EAB3-0E20-EB9F-59FC9C384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514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B8A593-D21A-4D6C-C6B0-A72091212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8C07F3-9487-E4E6-E92A-C9B39FA11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4F97B-A0A0-20E6-3996-A5CD4A3D7B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EC69E1-8115-5A40-8A9E-D43B0EE3DB6E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D2A29-D050-F2B0-E60A-555895F7F3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8A6F11-3ED3-2EB6-D203-4A90D4775A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7714DB-AAC8-6A48-973C-E3889A43E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801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table with numbers and text&#10;&#10;Description automatically generated">
            <a:extLst>
              <a:ext uri="{FF2B5EF4-FFF2-40B4-BE49-F238E27FC236}">
                <a16:creationId xmlns:a16="http://schemas.microsoft.com/office/drawing/2014/main" id="{84F2206C-32AC-CBCB-EC35-3635D6B33B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0825" y="0"/>
            <a:ext cx="9010349" cy="6798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30273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people with different colored lines&#10;&#10;Description automatically generated">
            <a:extLst>
              <a:ext uri="{FF2B5EF4-FFF2-40B4-BE49-F238E27FC236}">
                <a16:creationId xmlns:a16="http://schemas.microsoft.com/office/drawing/2014/main" id="{FBFD7C3D-1EEA-14E6-70D8-C66D52A5BB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8716" y="591457"/>
            <a:ext cx="8129055" cy="527115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D40A7C7-FCF1-1C30-EBB6-AC829D9D578A}"/>
              </a:ext>
            </a:extLst>
          </p:cNvPr>
          <p:cNvSpPr txBox="1"/>
          <p:nvPr/>
        </p:nvSpPr>
        <p:spPr>
          <a:xfrm>
            <a:off x="1257006" y="5745790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172                    100                       39                       3</a:t>
            </a:r>
          </a:p>
          <a:p>
            <a:r>
              <a:rPr lang="en-US" sz="1600" dirty="0">
                <a:latin typeface=""/>
              </a:rPr>
              <a:t>TACE.           117                     50                        22                       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A2C8D0-A5E8-E916-E714-27D219AA9ADC}"/>
              </a:ext>
            </a:extLst>
          </p:cNvPr>
          <p:cNvSpPr txBox="1"/>
          <p:nvPr/>
        </p:nvSpPr>
        <p:spPr>
          <a:xfrm>
            <a:off x="7023001" y="2660793"/>
            <a:ext cx="4344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001</a:t>
            </a:r>
          </a:p>
        </p:txBody>
      </p:sp>
    </p:spTree>
    <p:extLst>
      <p:ext uri="{BB962C8B-B14F-4D97-AF65-F5344CB8AC3E}">
        <p14:creationId xmlns:p14="http://schemas.microsoft.com/office/powerpoint/2010/main" val="4079469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number of people&#10;&#10;Description automatically generated">
            <a:extLst>
              <a:ext uri="{FF2B5EF4-FFF2-40B4-BE49-F238E27FC236}">
                <a16:creationId xmlns:a16="http://schemas.microsoft.com/office/drawing/2014/main" id="{AF5228EA-5FC8-CDDF-B9D5-CFF638B235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9567" y="278296"/>
            <a:ext cx="8512865" cy="520586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2606D0C-CE22-A9C5-ABF2-24F554C9E360}"/>
              </a:ext>
            </a:extLst>
          </p:cNvPr>
          <p:cNvSpPr txBox="1"/>
          <p:nvPr/>
        </p:nvSpPr>
        <p:spPr>
          <a:xfrm>
            <a:off x="1431323" y="5484158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172                    100                       39                       3</a:t>
            </a:r>
          </a:p>
          <a:p>
            <a:r>
              <a:rPr lang="en-US" sz="1600" dirty="0">
                <a:latin typeface=""/>
              </a:rPr>
              <a:t>TACE.           117                     50                        22                       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1228BD-41A7-5751-4E34-71F480B7A273}"/>
              </a:ext>
            </a:extLst>
          </p:cNvPr>
          <p:cNvSpPr txBox="1"/>
          <p:nvPr/>
        </p:nvSpPr>
        <p:spPr>
          <a:xfrm>
            <a:off x="7398558" y="2300880"/>
            <a:ext cx="4344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002</a:t>
            </a:r>
          </a:p>
        </p:txBody>
      </p:sp>
    </p:spTree>
    <p:extLst>
      <p:ext uri="{BB962C8B-B14F-4D97-AF65-F5344CB8AC3E}">
        <p14:creationId xmlns:p14="http://schemas.microsoft.com/office/powerpoint/2010/main" val="22155290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a survival graph&#10;&#10;Description automatically generated with medium confidence">
            <a:extLst>
              <a:ext uri="{FF2B5EF4-FFF2-40B4-BE49-F238E27FC236}">
                <a16:creationId xmlns:a16="http://schemas.microsoft.com/office/drawing/2014/main" id="{91E97060-9E16-2855-6FFE-D843B6553F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144" y="0"/>
            <a:ext cx="9563905" cy="593452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4863714-54B4-5DF4-6E43-A0AE4BA814E3}"/>
              </a:ext>
            </a:extLst>
          </p:cNvPr>
          <p:cNvSpPr txBox="1"/>
          <p:nvPr/>
        </p:nvSpPr>
        <p:spPr>
          <a:xfrm>
            <a:off x="7374454" y="2029351"/>
            <a:ext cx="4344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61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4C0DE0-A119-36E2-37B5-F65C915DD4A2}"/>
              </a:ext>
            </a:extLst>
          </p:cNvPr>
          <p:cNvSpPr txBox="1"/>
          <p:nvPr/>
        </p:nvSpPr>
        <p:spPr>
          <a:xfrm>
            <a:off x="840773" y="5652376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94                           82                            44                            6</a:t>
            </a:r>
          </a:p>
          <a:p>
            <a:r>
              <a:rPr lang="en-US" sz="1600" dirty="0">
                <a:latin typeface=""/>
              </a:rPr>
              <a:t>TACE.           94                           82                            41                           8</a:t>
            </a:r>
          </a:p>
        </p:txBody>
      </p:sp>
    </p:spTree>
    <p:extLst>
      <p:ext uri="{BB962C8B-B14F-4D97-AF65-F5344CB8AC3E}">
        <p14:creationId xmlns:p14="http://schemas.microsoft.com/office/powerpoint/2010/main" val="2326603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patient's survival&#10;&#10;Description automatically generated">
            <a:extLst>
              <a:ext uri="{FF2B5EF4-FFF2-40B4-BE49-F238E27FC236}">
                <a16:creationId xmlns:a16="http://schemas.microsoft.com/office/drawing/2014/main" id="{14F4BBCF-3BDC-B676-E0FA-8EC1F5FB73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9788" y="1"/>
            <a:ext cx="9332371" cy="59245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15E7471-1A64-2159-0ED0-BD380886E651}"/>
              </a:ext>
            </a:extLst>
          </p:cNvPr>
          <p:cNvSpPr txBox="1"/>
          <p:nvPr/>
        </p:nvSpPr>
        <p:spPr>
          <a:xfrm>
            <a:off x="7374454" y="2562751"/>
            <a:ext cx="4344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98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CC2824-CC4F-4BF5-F2B8-AF9A8C3B1A7F}"/>
              </a:ext>
            </a:extLst>
          </p:cNvPr>
          <p:cNvSpPr txBox="1"/>
          <p:nvPr/>
        </p:nvSpPr>
        <p:spPr>
          <a:xfrm>
            <a:off x="840773" y="5652376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  21                          16                             8                              1</a:t>
            </a:r>
          </a:p>
          <a:p>
            <a:r>
              <a:rPr lang="en-US" sz="1600" dirty="0">
                <a:latin typeface=""/>
              </a:rPr>
              <a:t>TACE.             21                          16                             8                              1</a:t>
            </a:r>
          </a:p>
        </p:txBody>
      </p:sp>
    </p:spTree>
    <p:extLst>
      <p:ext uri="{BB962C8B-B14F-4D97-AF65-F5344CB8AC3E}">
        <p14:creationId xmlns:p14="http://schemas.microsoft.com/office/powerpoint/2010/main" val="29397936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7EF23C2-0B51-4184-C08E-553B8D1326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7942" y="0"/>
            <a:ext cx="9211096" cy="584527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7E1C0B2-CABC-D830-8872-405500E8F5B4}"/>
              </a:ext>
            </a:extLst>
          </p:cNvPr>
          <p:cNvSpPr txBox="1"/>
          <p:nvPr/>
        </p:nvSpPr>
        <p:spPr>
          <a:xfrm>
            <a:off x="679622" y="5647038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201                        168                         88                           19</a:t>
            </a:r>
          </a:p>
          <a:p>
            <a:r>
              <a:rPr lang="en-US" sz="1600" dirty="0">
                <a:latin typeface=""/>
              </a:rPr>
              <a:t>TACE.          147                         123                         65                           1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EF2B6E7-A880-181F-FC9D-4F8253263AFD}"/>
              </a:ext>
            </a:extLst>
          </p:cNvPr>
          <p:cNvSpPr txBox="1"/>
          <p:nvPr/>
        </p:nvSpPr>
        <p:spPr>
          <a:xfrm>
            <a:off x="7587049" y="2654242"/>
            <a:ext cx="1076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129</a:t>
            </a:r>
          </a:p>
        </p:txBody>
      </p:sp>
    </p:spTree>
    <p:extLst>
      <p:ext uri="{BB962C8B-B14F-4D97-AF65-F5344CB8AC3E}">
        <p14:creationId xmlns:p14="http://schemas.microsoft.com/office/powerpoint/2010/main" val="4761038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5B59A2E-592E-2255-B3FD-7AB71762FBEF}"/>
              </a:ext>
            </a:extLst>
          </p:cNvPr>
          <p:cNvSpPr txBox="1"/>
          <p:nvPr/>
        </p:nvSpPr>
        <p:spPr>
          <a:xfrm>
            <a:off x="679622" y="5647038"/>
            <a:ext cx="932935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"/>
              </a:rPr>
              <a:t>No. at risk</a:t>
            </a:r>
          </a:p>
          <a:p>
            <a:r>
              <a:rPr lang="en-US" sz="1600" dirty="0">
                <a:latin typeface=""/>
              </a:rPr>
              <a:t>Ablation        201                        168                         88                           19</a:t>
            </a:r>
          </a:p>
          <a:p>
            <a:r>
              <a:rPr lang="en-US" sz="1600" dirty="0">
                <a:latin typeface=""/>
              </a:rPr>
              <a:t>TACE.          147                         123                         65                           12</a:t>
            </a:r>
          </a:p>
        </p:txBody>
      </p:sp>
      <p:pic>
        <p:nvPicPr>
          <p:cNvPr id="12" name="Picture 11" descr="A graph of a number of patients with cancer&#10;&#10;Description automatically generated with medium confidence">
            <a:extLst>
              <a:ext uri="{FF2B5EF4-FFF2-40B4-BE49-F238E27FC236}">
                <a16:creationId xmlns:a16="http://schemas.microsoft.com/office/drawing/2014/main" id="{E8B1D8C9-E77D-179B-C4E7-36129B2073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2145" y="107651"/>
            <a:ext cx="8792752" cy="554126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564C164-0089-777F-65AF-EB623C49A860}"/>
              </a:ext>
            </a:extLst>
          </p:cNvPr>
          <p:cNvSpPr txBox="1"/>
          <p:nvPr/>
        </p:nvSpPr>
        <p:spPr>
          <a:xfrm>
            <a:off x="7587049" y="2654242"/>
            <a:ext cx="1076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p=0.095</a:t>
            </a:r>
          </a:p>
        </p:txBody>
      </p:sp>
    </p:spTree>
    <p:extLst>
      <p:ext uri="{BB962C8B-B14F-4D97-AF65-F5344CB8AC3E}">
        <p14:creationId xmlns:p14="http://schemas.microsoft.com/office/powerpoint/2010/main" val="20066760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8A19A794-6C5F-2837-C4C4-B91CC62A0D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1443" y="851503"/>
            <a:ext cx="10469114" cy="4563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15589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D570FDF3-31E4-7477-1ABD-4356F33F39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443" y="686363"/>
            <a:ext cx="11341765" cy="495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9164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6</TotalTime>
  <Words>243</Words>
  <Application>Microsoft Office PowerPoint</Application>
  <PresentationFormat>Widescreen</PresentationFormat>
  <Paragraphs>42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ptos</vt:lpstr>
      <vt:lpstr>Aptos Display</vt:lpstr>
      <vt:lpstr>Arial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nathan Abdelmalak</dc:creator>
  <cp:lastModifiedBy>MDPI</cp:lastModifiedBy>
  <cp:revision>21</cp:revision>
  <dcterms:created xsi:type="dcterms:W3CDTF">2024-07-07T14:06:53Z</dcterms:created>
  <dcterms:modified xsi:type="dcterms:W3CDTF">2024-08-29T08:46:56Z</dcterms:modified>
</cp:coreProperties>
</file>